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0" r:id="rId2"/>
    <p:sldId id="275" r:id="rId3"/>
    <p:sldId id="273" r:id="rId4"/>
    <p:sldId id="269" r:id="rId5"/>
    <p:sldId id="274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5463" autoAdjust="0"/>
  </p:normalViewPr>
  <p:slideViewPr>
    <p:cSldViewPr snapToGrid="0">
      <p:cViewPr varScale="1">
        <p:scale>
          <a:sx n="97" d="100"/>
          <a:sy n="97" d="100"/>
        </p:scale>
        <p:origin x="1056" y="96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2" Type="http://schemas.openxmlformats.org/officeDocument/2006/relationships/image" Target="../media/image6.emf"/><Relationship Id="rId1" Type="http://schemas.openxmlformats.org/officeDocument/2006/relationships/image" Target="../media/image5.emf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Relationship Id="rId9" Type="http://schemas.openxmlformats.org/officeDocument/2006/relationships/image" Target="../media/image13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8B6DAB-0785-4E06-8282-2246BAF18785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C55F63-E5A4-4A22-B1CF-41D42767720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23329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igure</a:t>
            </a:r>
            <a:r>
              <a:rPr lang="en-GB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1.</a:t>
            </a:r>
            <a:r>
              <a:rPr lang="en-GB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OC curves for predicting ABMR using </a:t>
            </a:r>
            <a:r>
              <a:rPr lang="en-GB" altLang="ko-KR" sz="1200" b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FI</a:t>
            </a:r>
            <a:r>
              <a:rPr lang="en-GB" altLang="ko-KR" sz="1200" b="1" kern="1200" baseline="300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ak</a:t>
            </a:r>
            <a:r>
              <a:rPr lang="en-GB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GB" altLang="ko-KR" sz="1200" b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FI</a:t>
            </a:r>
            <a:r>
              <a:rPr lang="en-GB" altLang="ko-KR" sz="1200" b="1" kern="1200" baseline="300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m</a:t>
            </a:r>
            <a:r>
              <a:rPr lang="en-GB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GB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blue line indicates the ROC curve for prediction of ABMR using the </a:t>
            </a:r>
            <a:r>
              <a:rPr lang="en-GB" altLang="ko-KR" sz="1200" b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FI</a:t>
            </a:r>
            <a:r>
              <a:rPr lang="en-GB" altLang="ko-KR" sz="1200" b="0" kern="1200" baseline="300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ak</a:t>
            </a:r>
            <a:r>
              <a:rPr lang="en-GB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 red line indicates the ROC curve for prediction of ABMR using the </a:t>
            </a:r>
            <a:r>
              <a:rPr lang="en-GB" altLang="ko-KR" sz="1200" b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FI</a:t>
            </a:r>
            <a:r>
              <a:rPr lang="en-GB" altLang="ko-KR" sz="1200" b="0" kern="1200" baseline="300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m</a:t>
            </a:r>
            <a:r>
              <a:rPr lang="en-GB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altLang="ko-KR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AUC values were 0.622 (95% CI: 0.427–0.818) for </a:t>
            </a:r>
            <a:r>
              <a:rPr lang="en-US" altLang="ko-KR" sz="1200" b="0" i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FI</a:t>
            </a:r>
            <a:r>
              <a:rPr lang="en-US" altLang="ko-KR" sz="1200" b="0" i="0" kern="1200" baseline="300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ak</a:t>
            </a:r>
            <a:r>
              <a:rPr lang="en-US" altLang="ko-KR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0.622 (95% CI: 0.425–0.820) for </a:t>
            </a:r>
            <a:r>
              <a:rPr lang="en-US" altLang="ko-KR" sz="1200" b="0" i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FI</a:t>
            </a:r>
            <a:r>
              <a:rPr lang="en-US" altLang="ko-KR" sz="1200" b="0" i="0" kern="1200" baseline="300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m</a:t>
            </a:r>
            <a:r>
              <a:rPr lang="en-US" altLang="ko-KR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respectively.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optimal cut-off values for predicting ABMR were determined to be 5362 for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FI</a:t>
            </a:r>
            <a:r>
              <a:rPr lang="en-US" altLang="ko-KR" sz="1200" kern="1200" baseline="300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ak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10724 for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FI</a:t>
            </a:r>
            <a:r>
              <a:rPr lang="en-US" altLang="ko-KR" sz="1200" kern="1200" baseline="300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m</a:t>
            </a:r>
            <a:r>
              <a:rPr lang="en-GB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ABMR,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ibody-mediated rejection;</a:t>
            </a:r>
            <a:r>
              <a:rPr lang="en-US" altLang="ko-K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UC, area under the receiver operating characteristic; 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LA-DSA, </a:t>
            </a:r>
            <a:r>
              <a:rPr lang="en-GB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nor-specific anti-human leukocyte antigen antibody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FI</a:t>
            </a:r>
            <a:r>
              <a:rPr lang="en-US" altLang="ko-KR" sz="1200" kern="1200" baseline="300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ak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peak MFI;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FI</a:t>
            </a:r>
            <a:r>
              <a:rPr lang="en-US" altLang="ko-KR" sz="1200" kern="1200" baseline="300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m</a:t>
            </a:r>
            <a:r>
              <a:rPr lang="en-US" altLang="ko-K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altLang="ko-KR" sz="1200" u="non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otal MFI of all HLA-DSAs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OC, receiver</a:t>
            </a:r>
            <a:r>
              <a:rPr lang="en-US" altLang="ko-K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perating characteristic. </a:t>
            </a:r>
            <a:endParaRPr lang="en-GB" altLang="ko-KR" sz="1200" b="1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0C55F63-E5A4-4A22-B1CF-41D427677208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05003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igure</a:t>
            </a:r>
            <a:r>
              <a:rPr lang="en-GB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2.</a:t>
            </a:r>
            <a:r>
              <a:rPr lang="en-GB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velopment of BPAR in the first year of transplantation in patients with HLA-DSA according to the implementation of desensitization therapy. </a:t>
            </a:r>
            <a:r>
              <a:rPr lang="en-GB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BMR,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ibody-mediated rejection;</a:t>
            </a:r>
            <a:r>
              <a:rPr lang="en-US" altLang="ko-K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PAR, biopsy-proven allograft rejection; HLA-DSA, </a:t>
            </a:r>
            <a:r>
              <a:rPr lang="en-GB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nor-specific anti-human leukocyte antigen antibody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DSZ,</a:t>
            </a:r>
            <a:r>
              <a:rPr lang="en-US" altLang="ko-K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sensitization; 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CMR, T-cell mediated rejection. </a:t>
            </a:r>
            <a:endParaRPr lang="en-GB" altLang="ko-KR" sz="1200" b="1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0C55F63-E5A4-4A22-B1CF-41D427677208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12988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</a:t>
            </a:r>
            <a:r>
              <a:rPr lang="en-GB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.</a:t>
            </a:r>
            <a:r>
              <a:rPr lang="en-GB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velopment of BPAR in the first year of transplantation in patients with HLA-DSA according to the implementation of desensitization therapy</a:t>
            </a:r>
            <a:r>
              <a:rPr lang="en-US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stratified by HLA-DSA MFI values.</a:t>
            </a:r>
            <a:r>
              <a:rPr lang="en-GB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BMR,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ibody-mediated rejection;</a:t>
            </a:r>
            <a:r>
              <a:rPr lang="en-US" altLang="ko-K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PAR, biopsy-proven allograft rejection; HLA-DSA, </a:t>
            </a:r>
            <a:r>
              <a:rPr lang="en-GB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nor-specific anti-human leukocyte antigen antibody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DSZ,</a:t>
            </a:r>
            <a:r>
              <a:rPr lang="en-US" altLang="ko-K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sensitization; 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CMR, T-cell mediated rejection. </a:t>
            </a:r>
            <a:endParaRPr lang="en-GB" altLang="ko-KR" sz="1200" b="1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0C55F63-E5A4-4A22-B1CF-41D427677208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125989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</a:t>
            </a:r>
            <a:r>
              <a:rPr lang="en-US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4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Comparison of kidney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lograft function based on </a:t>
            </a:r>
            <a:r>
              <a:rPr lang="en-US" altLang="ko-KR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GFR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sing CKD-EPI equation (mL/min/1.73m</a:t>
            </a:r>
            <a:r>
              <a:rPr lang="en-US" altLang="ko-KR" sz="1200" b="1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ccording to the desensitization among patients with HLA-DSA.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KD-EPI, Chronic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idney Disease-Epidemiology Collaboration;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GFR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estimated glomerular filtration rate; 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LA-DSA, </a:t>
            </a:r>
            <a:r>
              <a:rPr lang="en-GB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nor-specific anti-human leukocyte antigen antibody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altLang="ko-KR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0C55F63-E5A4-4A22-B1CF-41D427677208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814541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</a:t>
            </a:r>
            <a:r>
              <a:rPr lang="en-GB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5</a:t>
            </a:r>
            <a:r>
              <a:rPr lang="en-GB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mparison of survival outcomes; (A) Death-censored graft survival (B) Patient survival (C) Infection-free survival.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numbers below the figures denote the numbers of KT recipients at risk in each subgroup. 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SZ, desensitization; 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LA-DSA, </a:t>
            </a:r>
            <a:r>
              <a:rPr lang="en-GB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nor-specific anti-human leukocyte antigen antibody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endParaRPr lang="en-GB" altLang="ko-KR" sz="1200" b="1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0C55F63-E5A4-4A22-B1CF-41D427677208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05412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1" y="1122364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1" y="3602042"/>
            <a:ext cx="9144000" cy="165576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F069E-1D34-4A5D-8FE0-A03E1CB61A65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4FDB7-7EE9-40D5-8212-ACFDC35E82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7958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F069E-1D34-4A5D-8FE0-A03E1CB61A65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4FDB7-7EE9-40D5-8212-ACFDC35E82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1519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F069E-1D34-4A5D-8FE0-A03E1CB61A65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4FDB7-7EE9-40D5-8212-ACFDC35E82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4396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F069E-1D34-4A5D-8FE0-A03E1CB61A65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4FDB7-7EE9-40D5-8212-ACFDC35E82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1770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42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8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F069E-1D34-4A5D-8FE0-A03E1CB61A65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4FDB7-7EE9-40D5-8212-ACFDC35E82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5714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1" y="1825626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6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F069E-1D34-4A5D-8FE0-A03E1CB61A65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4FDB7-7EE9-40D5-8212-ACFDC35E82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3413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8"/>
            <a:ext cx="10515600" cy="132556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5"/>
            <a:ext cx="51577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6"/>
            <a:ext cx="51577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5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6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F069E-1D34-4A5D-8FE0-A03E1CB61A65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4FDB7-7EE9-40D5-8212-ACFDC35E82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62786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F069E-1D34-4A5D-8FE0-A03E1CB61A65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4FDB7-7EE9-40D5-8212-ACFDC35E82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57590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F069E-1D34-4A5D-8FE0-A03E1CB61A65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4FDB7-7EE9-40D5-8212-ACFDC35E82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4117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5" y="457201"/>
            <a:ext cx="3932237" cy="1600201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30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5" y="2057399"/>
            <a:ext cx="3932237" cy="381158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F069E-1D34-4A5D-8FE0-A03E1CB61A65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4FDB7-7EE9-40D5-8212-ACFDC35E82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7797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5" y="457201"/>
            <a:ext cx="3932237" cy="1600201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30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5" y="2057399"/>
            <a:ext cx="3932237" cy="381158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F069E-1D34-4A5D-8FE0-A03E1CB61A65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54FDB7-7EE9-40D5-8212-ACFDC35E82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0417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1" y="365128"/>
            <a:ext cx="10515600" cy="13255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1" y="1825626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6F069E-1D34-4A5D-8FE0-A03E1CB61A65}" type="datetimeFigureOut">
              <a:rPr lang="ko-KR" altLang="en-US" smtClean="0"/>
              <a:t>2024-06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1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54FDB7-7EE9-40D5-8212-ACFDC35E823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2124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13" Type="http://schemas.openxmlformats.org/officeDocument/2006/relationships/image" Target="../media/image9.emf"/><Relationship Id="rId18" Type="http://schemas.openxmlformats.org/officeDocument/2006/relationships/oleObject" Target="../embeddings/oleObject11.bin"/><Relationship Id="rId3" Type="http://schemas.openxmlformats.org/officeDocument/2006/relationships/notesSlide" Target="../notesSlides/notesSlide3.xml"/><Relationship Id="rId21" Type="http://schemas.openxmlformats.org/officeDocument/2006/relationships/image" Target="../media/image13.emf"/><Relationship Id="rId7" Type="http://schemas.openxmlformats.org/officeDocument/2006/relationships/image" Target="../media/image6.emf"/><Relationship Id="rId12" Type="http://schemas.openxmlformats.org/officeDocument/2006/relationships/oleObject" Target="../embeddings/oleObject8.bin"/><Relationship Id="rId17" Type="http://schemas.openxmlformats.org/officeDocument/2006/relationships/image" Target="../media/image11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10.bin"/><Relationship Id="rId20" Type="http://schemas.openxmlformats.org/officeDocument/2006/relationships/oleObject" Target="../embeddings/oleObject12.bin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5.bin"/><Relationship Id="rId11" Type="http://schemas.openxmlformats.org/officeDocument/2006/relationships/image" Target="../media/image8.emf"/><Relationship Id="rId5" Type="http://schemas.openxmlformats.org/officeDocument/2006/relationships/image" Target="../media/image5.emf"/><Relationship Id="rId15" Type="http://schemas.openxmlformats.org/officeDocument/2006/relationships/image" Target="../media/image10.emf"/><Relationship Id="rId10" Type="http://schemas.openxmlformats.org/officeDocument/2006/relationships/oleObject" Target="../embeddings/oleObject7.bin"/><Relationship Id="rId19" Type="http://schemas.openxmlformats.org/officeDocument/2006/relationships/image" Target="../media/image12.emf"/><Relationship Id="rId4" Type="http://schemas.openxmlformats.org/officeDocument/2006/relationships/oleObject" Target="../embeddings/oleObject4.bin"/><Relationship Id="rId9" Type="http://schemas.openxmlformats.org/officeDocument/2006/relationships/image" Target="../media/image7.emf"/><Relationship Id="rId14" Type="http://schemas.openxmlformats.org/officeDocument/2006/relationships/oleObject" Target="../embeddings/oleObject9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14.emf"/><Relationship Id="rId4" Type="http://schemas.openxmlformats.org/officeDocument/2006/relationships/oleObject" Target="../embeddings/oleObject13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그림 16"/>
          <p:cNvPicPr>
            <a:picLocks noChangeAspect="1"/>
          </p:cNvPicPr>
          <p:nvPr/>
        </p:nvPicPr>
        <p:blipFill rotWithShape="1">
          <a:blip r:embed="rId3"/>
          <a:srcRect t="7291"/>
          <a:stretch/>
        </p:blipFill>
        <p:spPr>
          <a:xfrm>
            <a:off x="3307597" y="1998469"/>
            <a:ext cx="5576806" cy="4739223"/>
          </a:xfrm>
          <a:prstGeom prst="rect">
            <a:avLst/>
          </a:prstGeom>
        </p:spPr>
      </p:pic>
      <p:sp>
        <p:nvSpPr>
          <p:cNvPr id="6" name="제목 1"/>
          <p:cNvSpPr>
            <a:spLocks noGrp="1"/>
          </p:cNvSpPr>
          <p:nvPr>
            <p:ph type="title"/>
          </p:nvPr>
        </p:nvSpPr>
        <p:spPr>
          <a:xfrm>
            <a:off x="838201" y="365128"/>
            <a:ext cx="10515600" cy="1325564"/>
          </a:xfrm>
        </p:spPr>
        <p:txBody>
          <a:bodyPr/>
          <a:lstStyle/>
          <a:p>
            <a:pPr algn="ctr"/>
            <a:r>
              <a:rPr lang="en-US" altLang="ko-KR" b="1" dirty="0" smtClean="0"/>
              <a:t>Supplementary Figure S1</a:t>
            </a:r>
            <a:endParaRPr lang="ko-KR" altLang="en-US" b="1" dirty="0"/>
          </a:p>
        </p:txBody>
      </p:sp>
      <p:sp>
        <p:nvSpPr>
          <p:cNvPr id="3" name="직사각형 2"/>
          <p:cNvSpPr/>
          <p:nvPr/>
        </p:nvSpPr>
        <p:spPr>
          <a:xfrm>
            <a:off x="3508721" y="1690692"/>
            <a:ext cx="517455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OC curves for predicting ABMR using </a:t>
            </a:r>
            <a:r>
              <a:rPr lang="en-US" altLang="ko-K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FI</a:t>
            </a:r>
            <a:r>
              <a:rPr lang="en-US" altLang="ko-KR" sz="1400" b="1" baseline="30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ak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ko-K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FI</a:t>
            </a:r>
            <a:r>
              <a:rPr lang="en-US" altLang="ko-KR" sz="1400" b="1" baseline="30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m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7603412" y="5494400"/>
            <a:ext cx="776205" cy="2362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</a:t>
            </a:r>
            <a:r>
              <a:rPr lang="en-US" altLang="ko-KR" sz="1400" baseline="300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m</a:t>
            </a:r>
            <a:endParaRPr lang="ko-KR" altLang="en-US" sz="1400" dirty="0">
              <a:solidFill>
                <a:schemeClr val="tx1"/>
              </a:solidFill>
            </a:endParaRPr>
          </a:p>
        </p:txBody>
      </p:sp>
      <p:sp>
        <p:nvSpPr>
          <p:cNvPr id="16" name="직사각형 15"/>
          <p:cNvSpPr/>
          <p:nvPr/>
        </p:nvSpPr>
        <p:spPr>
          <a:xfrm>
            <a:off x="7603413" y="5227196"/>
            <a:ext cx="776205" cy="2362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</a:t>
            </a:r>
            <a:r>
              <a:rPr lang="en-US" altLang="ko-KR" sz="1400" baseline="300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ak</a:t>
            </a:r>
            <a:endParaRPr lang="ko-KR" altLang="en-US" sz="14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56794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개체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9433947"/>
              </p:ext>
            </p:extLst>
          </p:nvPr>
        </p:nvGraphicFramePr>
        <p:xfrm>
          <a:off x="7584051" y="2314168"/>
          <a:ext cx="3492500" cy="3014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98" name="Prism 10" r:id="rId4" imgW="2585774" imgH="2230434" progId="Prism10.Document">
                  <p:embed/>
                </p:oleObj>
              </mc:Choice>
              <mc:Fallback>
                <p:oleObj name="Prism 10" r:id="rId4" imgW="2585774" imgH="2230434" progId="Prism10.Document">
                  <p:embed/>
                  <p:pic>
                    <p:nvPicPr>
                      <p:cNvPr id="9" name="개체 8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584051" y="2314168"/>
                        <a:ext cx="3492500" cy="3014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개체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8605163"/>
              </p:ext>
            </p:extLst>
          </p:nvPr>
        </p:nvGraphicFramePr>
        <p:xfrm>
          <a:off x="704850" y="2316163"/>
          <a:ext cx="3490913" cy="3011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99" name="Prism 10" r:id="rId6" imgW="2634393" imgH="2271852" progId="Prism10.Document">
                  <p:embed/>
                </p:oleObj>
              </mc:Choice>
              <mc:Fallback>
                <p:oleObj name="Prism 10" r:id="rId6" imgW="2634393" imgH="2271852" progId="Prism10.Document">
                  <p:embed/>
                  <p:pic>
                    <p:nvPicPr>
                      <p:cNvPr id="10" name="개체 9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04850" y="2316163"/>
                        <a:ext cx="3490913" cy="3011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개체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5572655"/>
              </p:ext>
            </p:extLst>
          </p:nvPr>
        </p:nvGraphicFramePr>
        <p:xfrm>
          <a:off x="4171950" y="2314575"/>
          <a:ext cx="3457575" cy="3013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00" name="Prism 10" r:id="rId8" imgW="2600900" imgH="2267170" progId="Prism10.Document">
                  <p:embed/>
                </p:oleObj>
              </mc:Choice>
              <mc:Fallback>
                <p:oleObj name="Prism 10" r:id="rId8" imgW="2600900" imgH="2267170" progId="Prism10.Document">
                  <p:embed/>
                  <p:pic>
                    <p:nvPicPr>
                      <p:cNvPr id="11" name="개체 10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171950" y="2314575"/>
                        <a:ext cx="3457575" cy="3013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제목 1"/>
          <p:cNvSpPr>
            <a:spLocks noGrp="1"/>
          </p:cNvSpPr>
          <p:nvPr>
            <p:ph type="title"/>
          </p:nvPr>
        </p:nvSpPr>
        <p:spPr>
          <a:xfrm>
            <a:off x="838201" y="365128"/>
            <a:ext cx="10515600" cy="1325564"/>
          </a:xfrm>
        </p:spPr>
        <p:txBody>
          <a:bodyPr/>
          <a:lstStyle/>
          <a:p>
            <a:pPr algn="ctr"/>
            <a:r>
              <a:rPr lang="en-US" altLang="ko-KR" b="1" dirty="0" smtClean="0"/>
              <a:t>Supplementary Figure S2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190388154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4" name="개체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4597839"/>
              </p:ext>
            </p:extLst>
          </p:nvPr>
        </p:nvGraphicFramePr>
        <p:xfrm>
          <a:off x="7201885" y="1690692"/>
          <a:ext cx="1951384" cy="16748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28" name="Prism 10" r:id="rId4" imgW="2598019" imgH="2230434" progId="Prism10.Document">
                  <p:embed/>
                </p:oleObj>
              </mc:Choice>
              <mc:Fallback>
                <p:oleObj name="Prism 10" r:id="rId4" imgW="2598019" imgH="2230434" progId="Prism10.Document">
                  <p:embed/>
                  <p:pic>
                    <p:nvPicPr>
                      <p:cNvPr id="20" name="개체 19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201885" y="1690692"/>
                        <a:ext cx="1951384" cy="16748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개체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0590942"/>
              </p:ext>
            </p:extLst>
          </p:nvPr>
        </p:nvGraphicFramePr>
        <p:xfrm>
          <a:off x="3352602" y="1690692"/>
          <a:ext cx="1943036" cy="16748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29" name="Prism 10" r:id="rId6" imgW="2634393" imgH="2270051" progId="Prism10.Document">
                  <p:embed/>
                </p:oleObj>
              </mc:Choice>
              <mc:Fallback>
                <p:oleObj name="Prism 10" r:id="rId6" imgW="2634393" imgH="2270051" progId="Prism10.Document">
                  <p:embed/>
                  <p:pic>
                    <p:nvPicPr>
                      <p:cNvPr id="22" name="개체 21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352602" y="1690692"/>
                        <a:ext cx="1943036" cy="16748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개체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53677"/>
              </p:ext>
            </p:extLst>
          </p:nvPr>
        </p:nvGraphicFramePr>
        <p:xfrm>
          <a:off x="5228475" y="1690692"/>
          <a:ext cx="1973410" cy="16682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30" name="Prism 10" r:id="rId8" imgW="2680130" imgH="2265729" progId="Prism10.Document">
                  <p:embed/>
                </p:oleObj>
              </mc:Choice>
              <mc:Fallback>
                <p:oleObj name="Prism 10" r:id="rId8" imgW="2680130" imgH="2265729" progId="Prism10.Document">
                  <p:embed/>
                  <p:pic>
                    <p:nvPicPr>
                      <p:cNvPr id="23" name="개체 22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228475" y="1690692"/>
                        <a:ext cx="1973410" cy="16682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개체 3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887746"/>
              </p:ext>
            </p:extLst>
          </p:nvPr>
        </p:nvGraphicFramePr>
        <p:xfrm>
          <a:off x="3324482" y="3365500"/>
          <a:ext cx="1968500" cy="1697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31" name="Prism 9" r:id="rId10" imgW="2634393" imgH="2270051" progId="Prism9.Document">
                  <p:embed/>
                </p:oleObj>
              </mc:Choice>
              <mc:Fallback>
                <p:oleObj name="Prism 9" r:id="rId10" imgW="2634393" imgH="2270051" progId="Prism9.Document">
                  <p:embed/>
                  <p:pic>
                    <p:nvPicPr>
                      <p:cNvPr id="17" name="개체 16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324482" y="3365500"/>
                        <a:ext cx="1968500" cy="1697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개체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3507538"/>
              </p:ext>
            </p:extLst>
          </p:nvPr>
        </p:nvGraphicFramePr>
        <p:xfrm>
          <a:off x="5299332" y="3309938"/>
          <a:ext cx="1903412" cy="1817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32" name="Prism 9" r:id="rId12" imgW="2549041" imgH="2436442" progId="Prism9.Document">
                  <p:embed/>
                </p:oleObj>
              </mc:Choice>
              <mc:Fallback>
                <p:oleObj name="Prism 9" r:id="rId12" imgW="2549041" imgH="2436442" progId="Prism9.Document">
                  <p:embed/>
                  <p:pic>
                    <p:nvPicPr>
                      <p:cNvPr id="18" name="개체 17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299332" y="3309938"/>
                        <a:ext cx="1903412" cy="1817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개체 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7487237"/>
              </p:ext>
            </p:extLst>
          </p:nvPr>
        </p:nvGraphicFramePr>
        <p:xfrm>
          <a:off x="7205919" y="3316288"/>
          <a:ext cx="1930400" cy="180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33" name="Prism 9" r:id="rId14" imgW="2542918" imgH="2377017" progId="Prism9.Document">
                  <p:embed/>
                </p:oleObj>
              </mc:Choice>
              <mc:Fallback>
                <p:oleObj name="Prism 9" r:id="rId14" imgW="2542918" imgH="2377017" progId="Prism9.Document">
                  <p:embed/>
                  <p:pic>
                    <p:nvPicPr>
                      <p:cNvPr id="19" name="개체 18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7205919" y="3316288"/>
                        <a:ext cx="1930400" cy="180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개체 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4913073"/>
              </p:ext>
            </p:extLst>
          </p:nvPr>
        </p:nvGraphicFramePr>
        <p:xfrm>
          <a:off x="3332419" y="5011738"/>
          <a:ext cx="1960563" cy="1689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34" name="Prism 9" r:id="rId16" imgW="2634393" imgH="2270051" progId="Prism9.Document">
                  <p:embed/>
                </p:oleObj>
              </mc:Choice>
              <mc:Fallback>
                <p:oleObj name="Prism 9" r:id="rId16" imgW="2634393" imgH="2270051" progId="Prism9.Document">
                  <p:embed/>
                  <p:pic>
                    <p:nvPicPr>
                      <p:cNvPr id="20" name="개체 19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332419" y="5011738"/>
                        <a:ext cx="1960563" cy="1689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개체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5235913"/>
              </p:ext>
            </p:extLst>
          </p:nvPr>
        </p:nvGraphicFramePr>
        <p:xfrm>
          <a:off x="5295638" y="5010854"/>
          <a:ext cx="1973410" cy="16984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35" name="Prism 10" r:id="rId18" imgW="2631512" imgH="2265729" progId="Prism10.Document">
                  <p:embed/>
                </p:oleObj>
              </mc:Choice>
              <mc:Fallback>
                <p:oleObj name="Prism 10" r:id="rId18" imgW="2631512" imgH="2265729" progId="Prism10.Document">
                  <p:embed/>
                  <p:pic>
                    <p:nvPicPr>
                      <p:cNvPr id="22" name="개체 21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5295638" y="5010854"/>
                        <a:ext cx="1973410" cy="16984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개체 4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7147244"/>
              </p:ext>
            </p:extLst>
          </p:nvPr>
        </p:nvGraphicFramePr>
        <p:xfrm>
          <a:off x="7269047" y="5004305"/>
          <a:ext cx="1973410" cy="16978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36" name="Prism 10" r:id="rId20" imgW="2591897" imgH="2230434" progId="Prism10.Document">
                  <p:embed/>
                </p:oleObj>
              </mc:Choice>
              <mc:Fallback>
                <p:oleObj name="Prism 10" r:id="rId20" imgW="2591897" imgH="2230434" progId="Prism10.Document">
                  <p:embed/>
                  <p:pic>
                    <p:nvPicPr>
                      <p:cNvPr id="23" name="개체 22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7269047" y="5004305"/>
                        <a:ext cx="1973410" cy="16978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5" name="직사각형 44"/>
          <p:cNvSpPr/>
          <p:nvPr/>
        </p:nvSpPr>
        <p:spPr>
          <a:xfrm>
            <a:off x="1753925" y="2363254"/>
            <a:ext cx="1109599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500" b="1" dirty="0" smtClean="0">
                <a:latin typeface="Arial" charset="0"/>
                <a:cs typeface="Arial" charset="0"/>
              </a:rPr>
              <a:t>MFI&lt;5000 </a:t>
            </a:r>
            <a:endParaRPr lang="ko-KR" altLang="en-US" sz="1500" dirty="0"/>
          </a:p>
        </p:txBody>
      </p:sp>
      <p:sp>
        <p:nvSpPr>
          <p:cNvPr id="46" name="직사각형 45"/>
          <p:cNvSpPr/>
          <p:nvPr/>
        </p:nvSpPr>
        <p:spPr>
          <a:xfrm>
            <a:off x="1509469" y="4053588"/>
            <a:ext cx="1641796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500" b="1" dirty="0">
                <a:latin typeface="Arial" charset="0"/>
                <a:cs typeface="Arial" charset="0"/>
              </a:rPr>
              <a:t>MFI </a:t>
            </a:r>
            <a:r>
              <a:rPr lang="en-US" altLang="ko-KR" sz="1500" b="1" dirty="0" smtClean="0">
                <a:latin typeface="Arial" charset="0"/>
                <a:cs typeface="Arial" charset="0"/>
              </a:rPr>
              <a:t>5000–10000</a:t>
            </a:r>
            <a:endParaRPr lang="ko-KR" altLang="en-US" sz="1500" dirty="0"/>
          </a:p>
        </p:txBody>
      </p:sp>
      <p:sp>
        <p:nvSpPr>
          <p:cNvPr id="47" name="직사각형 46"/>
          <p:cNvSpPr/>
          <p:nvPr/>
        </p:nvSpPr>
        <p:spPr>
          <a:xfrm>
            <a:off x="1753925" y="5743922"/>
            <a:ext cx="1164101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500" b="1" dirty="0" smtClean="0">
                <a:latin typeface="Arial" charset="0"/>
                <a:cs typeface="Arial" charset="0"/>
              </a:rPr>
              <a:t>MFI&gt;10000</a:t>
            </a:r>
            <a:endParaRPr lang="ko-KR" altLang="en-US" sz="1500" dirty="0"/>
          </a:p>
        </p:txBody>
      </p:sp>
      <p:sp>
        <p:nvSpPr>
          <p:cNvPr id="21" name="제목 1"/>
          <p:cNvSpPr txBox="1">
            <a:spLocks/>
          </p:cNvSpPr>
          <p:nvPr/>
        </p:nvSpPr>
        <p:spPr>
          <a:xfrm>
            <a:off x="838201" y="365128"/>
            <a:ext cx="10515600" cy="13255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ko-KR" b="1" dirty="0" smtClean="0"/>
              <a:t>Supplementary Figure S3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181830589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개체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3851317"/>
              </p:ext>
            </p:extLst>
          </p:nvPr>
        </p:nvGraphicFramePr>
        <p:xfrm>
          <a:off x="1088232" y="1690692"/>
          <a:ext cx="10015538" cy="4989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54" name="Prism 10" r:id="rId4" imgW="6098178" imgH="3037179" progId="Prism10.Document">
                  <p:embed/>
                </p:oleObj>
              </mc:Choice>
              <mc:Fallback>
                <p:oleObj name="Prism 10" r:id="rId4" imgW="6098178" imgH="303717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88232" y="1690692"/>
                        <a:ext cx="10015538" cy="4989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제목 1"/>
          <p:cNvSpPr>
            <a:spLocks noGrp="1"/>
          </p:cNvSpPr>
          <p:nvPr>
            <p:ph type="title"/>
          </p:nvPr>
        </p:nvSpPr>
        <p:spPr>
          <a:xfrm>
            <a:off x="838201" y="365128"/>
            <a:ext cx="10515600" cy="1325564"/>
          </a:xfrm>
        </p:spPr>
        <p:txBody>
          <a:bodyPr/>
          <a:lstStyle/>
          <a:p>
            <a:pPr algn="ctr"/>
            <a:r>
              <a:rPr lang="en-US" altLang="ko-KR" b="1" dirty="0" smtClean="0"/>
              <a:t>Supplementary Figure S4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10534797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그림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64130" y="1941693"/>
            <a:ext cx="3970071" cy="3637391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82065" y="1930705"/>
            <a:ext cx="3982065" cy="3648380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1930704"/>
            <a:ext cx="3982065" cy="3648380"/>
          </a:xfrm>
          <a:prstGeom prst="rect">
            <a:avLst/>
          </a:prstGeom>
        </p:spPr>
      </p:pic>
      <p:sp>
        <p:nvSpPr>
          <p:cNvPr id="6" name="TextBox 1"/>
          <p:cNvSpPr txBox="1">
            <a:spLocks noChangeArrowheads="1"/>
          </p:cNvSpPr>
          <p:nvPr/>
        </p:nvSpPr>
        <p:spPr bwMode="auto">
          <a:xfrm>
            <a:off x="192602" y="1757027"/>
            <a:ext cx="58906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latinLnBrk="0" hangingPunct="0"/>
            <a:r>
              <a:rPr lang="en-US" altLang="ko-KR" b="1" dirty="0">
                <a:latin typeface="Arial" charset="0"/>
                <a:ea typeface="맑은 고딕" pitchFamily="50" charset="-127"/>
                <a:cs typeface="Arial" charset="0"/>
              </a:rPr>
              <a:t>(A)</a:t>
            </a:r>
            <a:endParaRPr lang="ko-KR" altLang="en-US" b="1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7" name="TextBox 1"/>
          <p:cNvSpPr txBox="1">
            <a:spLocks noChangeArrowheads="1"/>
          </p:cNvSpPr>
          <p:nvPr/>
        </p:nvSpPr>
        <p:spPr bwMode="auto">
          <a:xfrm>
            <a:off x="4169753" y="1757027"/>
            <a:ext cx="58906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latinLnBrk="0" hangingPunct="0"/>
            <a:r>
              <a:rPr lang="en-US" altLang="ko-KR" b="1" dirty="0">
                <a:latin typeface="Arial" charset="0"/>
                <a:ea typeface="맑은 고딕" pitchFamily="50" charset="-127"/>
                <a:cs typeface="Arial" charset="0"/>
              </a:rPr>
              <a:t>(B)</a:t>
            </a:r>
            <a:endParaRPr lang="ko-KR" altLang="en-US" b="1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8" name="TextBox 1"/>
          <p:cNvSpPr txBox="1">
            <a:spLocks noChangeArrowheads="1"/>
          </p:cNvSpPr>
          <p:nvPr/>
        </p:nvSpPr>
        <p:spPr bwMode="auto">
          <a:xfrm>
            <a:off x="8151818" y="1760608"/>
            <a:ext cx="58906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latinLnBrk="0" hangingPunct="0"/>
            <a:r>
              <a:rPr lang="en-US" altLang="ko-KR" b="1" dirty="0">
                <a:latin typeface="Arial" charset="0"/>
                <a:ea typeface="맑은 고딕" pitchFamily="50" charset="-127"/>
                <a:cs typeface="Arial" charset="0"/>
              </a:rPr>
              <a:t>(C)</a:t>
            </a:r>
            <a:endParaRPr lang="ko-KR" altLang="en-US" b="1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600526" y="2732140"/>
            <a:ext cx="1238865" cy="4719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500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5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824</a:t>
            </a:r>
            <a:endParaRPr lang="ko-KR" altLang="en-US" sz="15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직사각형 12"/>
          <p:cNvSpPr/>
          <p:nvPr/>
        </p:nvSpPr>
        <p:spPr>
          <a:xfrm>
            <a:off x="4582591" y="2732140"/>
            <a:ext cx="1238865" cy="4719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500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5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312</a:t>
            </a:r>
            <a:endParaRPr lang="ko-KR" altLang="en-US" sz="15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8579868" y="3204089"/>
            <a:ext cx="1238865" cy="4719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500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5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.060</a:t>
            </a:r>
            <a:endParaRPr lang="ko-KR" altLang="en-US" sz="15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제목 1"/>
          <p:cNvSpPr>
            <a:spLocks noGrp="1"/>
          </p:cNvSpPr>
          <p:nvPr>
            <p:ph type="title"/>
          </p:nvPr>
        </p:nvSpPr>
        <p:spPr>
          <a:xfrm>
            <a:off x="838201" y="365128"/>
            <a:ext cx="10515600" cy="1325564"/>
          </a:xfrm>
        </p:spPr>
        <p:txBody>
          <a:bodyPr/>
          <a:lstStyle/>
          <a:p>
            <a:pPr algn="ctr"/>
            <a:r>
              <a:rPr lang="en-US" altLang="ko-KR" b="1" dirty="0" smtClean="0"/>
              <a:t>Supplementary Figure S5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28732790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44</TotalTime>
  <Words>398</Words>
  <Application>Microsoft Office PowerPoint</Application>
  <PresentationFormat>와이드스크린</PresentationFormat>
  <Paragraphs>27</Paragraphs>
  <Slides>5</Slides>
  <Notes>5</Notes>
  <HiddenSlides>0</HiddenSlides>
  <MMClips>0</MMClips>
  <ScaleCrop>false</ScaleCrop>
  <HeadingPairs>
    <vt:vector size="8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2</vt:i4>
      </vt:variant>
      <vt:variant>
        <vt:lpstr>슬라이드 제목</vt:lpstr>
      </vt:variant>
      <vt:variant>
        <vt:i4>5</vt:i4>
      </vt:variant>
    </vt:vector>
  </HeadingPairs>
  <TitlesOfParts>
    <vt:vector size="10" baseType="lpstr">
      <vt:lpstr>맑은 고딕</vt:lpstr>
      <vt:lpstr>Arial</vt:lpstr>
      <vt:lpstr>Office 테마</vt:lpstr>
      <vt:lpstr>Prism 10</vt:lpstr>
      <vt:lpstr>Prism 9</vt:lpstr>
      <vt:lpstr>Supplementary Figure S1</vt:lpstr>
      <vt:lpstr>Supplementary Figure S2</vt:lpstr>
      <vt:lpstr>PowerPoint 프레젠테이션</vt:lpstr>
      <vt:lpstr>Supplementary Figure S4</vt:lpstr>
      <vt:lpstr>Supplementary Figure S5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하은</dc:creator>
  <cp:lastModifiedBy>USER</cp:lastModifiedBy>
  <cp:revision>226</cp:revision>
  <dcterms:created xsi:type="dcterms:W3CDTF">2022-12-31T04:08:01Z</dcterms:created>
  <dcterms:modified xsi:type="dcterms:W3CDTF">2024-06-12T13:49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Fasoo_Trace_ID">
    <vt:lpwstr>eyJub2RlMSI6eyJkc2QiOiIwMTAwMDAwMDAwMDAzMTk0IiwibG9nVGltZSI6IjIwMjMtMDItMTBUMDU6Mzg6NDBaIiwicElEIjoxLCJ0cmFjZUlkIjoiQTg3NDQ5MjE3Njc1NEJEMkI4RjVFNDMzRjlFOTBDQzkiLCJ1c2VyQ29kZSI6IjIyMTAxMjcyIn0sIm5vZGUyIjp7ImRzZCI6IjAxMDAwMDAwMDAwMDMxOTQiLCJsb2dUaW1lIjoiMjA</vt:lpwstr>
  </property>
  <property fmtid="{D5CDD505-2E9C-101B-9397-08002B2CF9AE}" pid="3" name="FDRClass">
    <vt:lpwstr>0</vt:lpwstr>
  </property>
  <property fmtid="{D5CDD505-2E9C-101B-9397-08002B2CF9AE}" pid="4" name="FDRSet">
    <vt:lpwstr>manual</vt:lpwstr>
  </property>
</Properties>
</file>